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12183A-FDEC-46BF-9C49-888C54F61D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2272909-85DC-4085-A67C-BCF4925FB2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A8FC1F5-BA29-4800-9E4A-180980A2A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3D632E0-BDF7-4C93-8BC7-BC4BF8188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DE8724-86A9-4962-8AFF-DF7488232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245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92B1942-097D-42AD-903D-9C04D8E982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5EB8F2E-5A4E-4A90-95C5-2555A92B1C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19FEB57-DC08-4FAC-91A1-BA4F300B8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E04F147-6230-4092-9147-F2BDBD00E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527D35A-EFE9-45B5-ADD3-974261C41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370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9E8C2F7-A66C-4915-80BA-8EFD89BD91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81C7584-DD29-4290-839B-164480E9E7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A55719E-4036-46F2-A1FE-0AE21F400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2F8610-F42B-4BD2-ABD0-6FD673D27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B031621-07C2-45FE-87F3-138B6CFA4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75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8F9653-E541-428A-9A79-6654A2945B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C987C78-B080-4F04-A4B4-1C897534F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297969F-B56A-4394-B6D1-92A83DDC9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9D870EC-2368-4A49-BD7A-D71B45A3B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BF42047-929D-4B23-BB27-2236E79A0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501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30DD774-8050-4F6C-A478-A2857B8B03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105D020-E464-4DD5-B588-329241C9F0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9AEDE0-0DE0-4A5E-AE0E-DC8A6BACF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DCFAE90-5FA9-4268-ADC7-BAF68D510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D9A0EEA-D8C2-4A7A-AAB0-CC8AB03BD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695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7CCB3C9-78B6-404C-A0CE-24E45D0733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F30668C-1C6A-4856-BA41-006205A281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2BD32F7-CC26-46F6-AB68-B709A08A9F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18AD4A2-1DC0-475E-A079-EA8434A27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3795EE9-D62F-4004-8078-8A79700EE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78BBFD0-B15C-4A9B-ABA2-CE0E148E3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292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EFD5B2E-B95E-4D1F-97F8-B018B87180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9CB333C-598F-4481-A827-031826FD74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20223D2-82B7-4E3A-A6A9-83B7E65F5D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15360CF-5DFD-4151-BBC3-5CE1C7936F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7FBE865-9F3E-4165-952C-7FD6F3D571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86CB9B5-D326-49EB-97CE-5394A2778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FD4E2C02-265A-4AD4-BF35-EFE30E091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3E5747D-42DE-4A00-8A72-CAA14DB7C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256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8B4E3B-C9E2-474B-8D96-93835A2AE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4DEFC2B-9C23-4EB6-9C5E-639060834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B69C286-6832-40E0-B554-D670603A8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E538B8A-075F-4FA0-B3B6-24686C7AA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003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8148CCA-19BF-4923-AD37-1F0C80F75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42C824E-2459-48DC-98F3-B9D04D0B1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8478492-3697-47BD-9890-7AFD62E2B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68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80B5D5-F4F7-4183-803F-1DF68C9E52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E4D0997-6B9A-49FE-ACD8-3731D37F4D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B99EECC-D287-4105-81CD-921A1719F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E0E0DBF-BFD1-4C53-918A-B7D91648D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82F2F4F-641F-40DC-B821-5FC0B2B46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9E4AD41-B03C-4B86-AAC6-75081EDE5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821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EB630E0-4DC9-4C63-891D-718703DAE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6C4E43A-78C3-46AE-80DF-856D403931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8FE0CA6-7DA0-493F-8A5B-06ED859D87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517E9F0-E013-42C1-A18B-5372049E0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E5CC9A0-7A02-4BA9-BF5F-2A92CA91F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1683E64-5927-47CF-AF7E-693EA7B3B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97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FDDCFEC-24C5-4C20-A399-EC0A36124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7E8AF3C-8BB9-4F89-9FD3-CCCDD1BF08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08DFCDD-7EFB-4359-BA83-7ADCFCF466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5964DB-5CEF-462F-B586-42D1EBAAACD4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047FD65-E392-4322-8DEC-19E00A5C3D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5278D3F-A89D-4326-AA82-7C0BFC9511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2A455-F7F7-4650-9643-D9DB35D0ED0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536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10D2C834-D67C-4288-A611-415293D57F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6399730"/>
              </p:ext>
            </p:extLst>
          </p:nvPr>
        </p:nvGraphicFramePr>
        <p:xfrm>
          <a:off x="710089" y="1015681"/>
          <a:ext cx="10914063" cy="48266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10" r:id="rId3" imgW="9922099" imgH="4388255" progId="Prism10.Document">
                  <p:embed/>
                </p:oleObj>
              </mc:Choice>
              <mc:Fallback>
                <p:oleObj name="Prism 10" r:id="rId3" imgW="9922099" imgH="438825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0089" y="1015681"/>
                        <a:ext cx="10914063" cy="48266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54F57589-1335-4AAB-A0A4-3915F5CB2DFC}"/>
              </a:ext>
            </a:extLst>
          </p:cNvPr>
          <p:cNvSpPr txBox="1"/>
          <p:nvPr/>
        </p:nvSpPr>
        <p:spPr>
          <a:xfrm>
            <a:off x="430560" y="952173"/>
            <a:ext cx="187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8473D083-00F6-4FF1-BFB6-A0C66999E951}"/>
              </a:ext>
            </a:extLst>
          </p:cNvPr>
          <p:cNvSpPr txBox="1"/>
          <p:nvPr/>
        </p:nvSpPr>
        <p:spPr>
          <a:xfrm>
            <a:off x="357051" y="261257"/>
            <a:ext cx="114853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upplementary material 4: prevalence (%) of ARGs according to sample type and antimicrobial use. A) water, B) </a:t>
            </a:r>
            <a:r>
              <a:rPr lang="en-US" sz="1600" dirty="0" err="1"/>
              <a:t>faecal</a:t>
            </a:r>
            <a:r>
              <a:rPr lang="en-US" sz="1600" dirty="0"/>
              <a:t>, and C) biofilm samples. Whiskers represent 95% CI.</a:t>
            </a:r>
          </a:p>
        </p:txBody>
      </p:sp>
    </p:spTree>
    <p:extLst>
      <p:ext uri="{BB962C8B-B14F-4D97-AF65-F5344CB8AC3E}">
        <p14:creationId xmlns:p14="http://schemas.microsoft.com/office/powerpoint/2010/main" val="2107479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2AF60D84-924A-4124-80E8-6D5E411D80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7208350"/>
              </p:ext>
            </p:extLst>
          </p:nvPr>
        </p:nvGraphicFramePr>
        <p:xfrm>
          <a:off x="605851" y="1015709"/>
          <a:ext cx="10980299" cy="48265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10" r:id="rId3" imgW="9982962" imgH="4388255" progId="Prism10.Document">
                  <p:embed/>
                </p:oleObj>
              </mc:Choice>
              <mc:Fallback>
                <p:oleObj name="Prism 10" r:id="rId3" imgW="9982962" imgH="4388255" progId="Prism10.Document">
                  <p:embed/>
                  <p:pic>
                    <p:nvPicPr>
                      <p:cNvPr id="5" name="Oggetto 4">
                        <a:extLst>
                          <a:ext uri="{FF2B5EF4-FFF2-40B4-BE49-F238E27FC236}">
                            <a16:creationId xmlns:a16="http://schemas.microsoft.com/office/drawing/2014/main" id="{2AF60D84-924A-4124-80E8-6D5E411D80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5851" y="1015709"/>
                        <a:ext cx="10980299" cy="48265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54F57589-1335-4AAB-A0A4-3915F5CB2DFC}"/>
              </a:ext>
            </a:extLst>
          </p:cNvPr>
          <p:cNvSpPr txBox="1"/>
          <p:nvPr/>
        </p:nvSpPr>
        <p:spPr>
          <a:xfrm>
            <a:off x="430560" y="952173"/>
            <a:ext cx="187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9818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2B834095-B764-4B39-91EC-47DF978BC2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1869210"/>
              </p:ext>
            </p:extLst>
          </p:nvPr>
        </p:nvGraphicFramePr>
        <p:xfrm>
          <a:off x="503695" y="1015709"/>
          <a:ext cx="11184610" cy="48265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10" r:id="rId3" imgW="10167351" imgH="4388255" progId="Prism10.Document">
                  <p:embed/>
                </p:oleObj>
              </mc:Choice>
              <mc:Fallback>
                <p:oleObj name="Prism 10" r:id="rId3" imgW="10167351" imgH="4388255" progId="Prism10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2B834095-B764-4B39-91EC-47DF978BC2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3695" y="1015709"/>
                        <a:ext cx="11184610" cy="48265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54F57589-1335-4AAB-A0A4-3915F5CB2DFC}"/>
              </a:ext>
            </a:extLst>
          </p:cNvPr>
          <p:cNvSpPr txBox="1"/>
          <p:nvPr/>
        </p:nvSpPr>
        <p:spPr>
          <a:xfrm>
            <a:off x="430560" y="952173"/>
            <a:ext cx="187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399295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9</Words>
  <Application>Microsoft Office PowerPoint</Application>
  <PresentationFormat>Widescreen</PresentationFormat>
  <Paragraphs>4</Paragraphs>
  <Slides>3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ism 10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5</cp:revision>
  <dcterms:created xsi:type="dcterms:W3CDTF">2024-02-22T15:46:42Z</dcterms:created>
  <dcterms:modified xsi:type="dcterms:W3CDTF">2024-12-05T13:47:03Z</dcterms:modified>
</cp:coreProperties>
</file>